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3"/>
  </p:notesMasterIdLst>
  <p:sldIdLst>
    <p:sldId id="826" r:id="rId2"/>
  </p:sldIdLst>
  <p:sldSz cx="9144000" cy="6858000" type="screen4x3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9999FF"/>
    <a:srgbClr val="0099CC"/>
    <a:srgbClr val="0000FF"/>
    <a:srgbClr val="00FF00"/>
    <a:srgbClr val="FF6600"/>
    <a:srgbClr val="FF9999"/>
    <a:srgbClr val="76DBE6"/>
    <a:srgbClr val="008000"/>
    <a:srgbClr val="3366FF"/>
    <a:srgbClr val="008F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56" autoAdjust="0"/>
    <p:restoredTop sz="93372" autoAdjust="0"/>
  </p:normalViewPr>
  <p:slideViewPr>
    <p:cSldViewPr>
      <p:cViewPr>
        <p:scale>
          <a:sx n="150" d="100"/>
          <a:sy n="150" d="100"/>
        </p:scale>
        <p:origin x="-66" y="-19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26833" cy="464185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56551" y="0"/>
            <a:ext cx="3026833" cy="464185"/>
          </a:xfrm>
          <a:prstGeom prst="rect">
            <a:avLst/>
          </a:prstGeom>
        </p:spPr>
        <p:txBody>
          <a:bodyPr vert="horz" lIns="92953" tIns="46477" rIns="92953" bIns="46477" rtlCol="0"/>
          <a:lstStyle>
            <a:lvl1pPr algn="r">
              <a:defRPr sz="1200"/>
            </a:lvl1pPr>
          </a:lstStyle>
          <a:p>
            <a:fld id="{99030AC8-39F8-483A-9789-3437045FB32F}" type="datetimeFigureOut">
              <a:rPr lang="en-US" smtClean="0"/>
              <a:t>8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71575" y="695325"/>
            <a:ext cx="4641850" cy="34813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53" tIns="46477" rIns="92953" bIns="46477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8500" y="4409758"/>
            <a:ext cx="5588000" cy="4177665"/>
          </a:xfrm>
          <a:prstGeom prst="rect">
            <a:avLst/>
          </a:prstGeom>
        </p:spPr>
        <p:txBody>
          <a:bodyPr vert="horz" lIns="92953" tIns="46477" rIns="92953" bIns="46477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17904"/>
            <a:ext cx="3026833" cy="464185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56551" y="8817904"/>
            <a:ext cx="3026833" cy="464185"/>
          </a:xfrm>
          <a:prstGeom prst="rect">
            <a:avLst/>
          </a:prstGeom>
        </p:spPr>
        <p:txBody>
          <a:bodyPr vert="horz" lIns="92953" tIns="46477" rIns="92953" bIns="46477" rtlCol="0" anchor="b"/>
          <a:lstStyle>
            <a:lvl1pPr algn="r">
              <a:defRPr sz="1200"/>
            </a:lvl1pPr>
          </a:lstStyle>
          <a:p>
            <a:fld id="{DE5F86FD-DFDC-450E-83F4-387E235786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737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dirty="0">
                <a:solidFill>
                  <a:srgbClr val="FF0000"/>
                </a:solidFill>
                <a:latin typeface="Arial" charset="0"/>
                <a:ea typeface="SimSun" pitchFamily="2" charset="-122"/>
              </a:rPr>
              <a:t>Final version</a:t>
            </a:r>
            <a:endParaRPr lang="zh-CN" altLang="en-US" dirty="0">
              <a:solidFill>
                <a:srgbClr val="FF0000"/>
              </a:solidFill>
              <a:latin typeface="Arial" charset="0"/>
              <a:ea typeface="SimSun" pitchFamily="2" charset="-122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5F86FD-DFDC-450E-83F4-387E2357862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6825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C5484D-A129-4813-B013-EF71309F1961}" type="datetime1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131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390019-DAE6-4B12-9394-0E874B23456C}" type="datetime1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733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AD0AF5-3F52-4358-B73E-374B1B8CA7E1}" type="datetime1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444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CF455D-45FD-4B95-9FFE-91083F0D80FE}" type="datetime1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931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D6B315-4003-4815-9976-892919C2E145}" type="datetime1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002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0DAB1F-F585-4626-9680-14A5F7F99D81}" type="datetime1">
              <a:rPr lang="en-US" smtClean="0"/>
              <a:t>8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929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B7CF2-D8E2-4398-95D6-859964547B0F}" type="datetime1">
              <a:rPr lang="en-US" smtClean="0"/>
              <a:t>8/1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965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9BB6BA-CB85-46A4-A042-C078DA2B6F67}" type="datetime1">
              <a:rPr lang="en-US" smtClean="0"/>
              <a:t>8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528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5AC05A-2C6B-4E93-A13C-34484EB25E2A}" type="datetime1">
              <a:rPr lang="en-US" smtClean="0"/>
              <a:t>8/1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819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11E8E5-83B6-4C4C-BFCA-AFA0F2926645}" type="datetime1">
              <a:rPr lang="en-US" smtClean="0"/>
              <a:t>8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097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869F28-0EFF-441C-88F5-9DAF23CDC0C8}" type="datetime1">
              <a:rPr lang="en-US" smtClean="0"/>
              <a:t>8/1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MSC Biopsy Paracrine Manuscript Figs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7690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66B0C5-41E1-4DCE-9185-22FC661AC4E1}" type="datetime1">
              <a:rPr lang="en-US" smtClean="0"/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MSC Biopsy Paracrine Manuscript Fig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2BFED-E0C9-4700-A7BC-F7F3A2EAE09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309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TextBox 87">
            <a:extLst>
              <a:ext uri="{FF2B5EF4-FFF2-40B4-BE49-F238E27FC236}">
                <a16:creationId xmlns:a16="http://schemas.microsoft.com/office/drawing/2014/main" id="{5EAC2976-6193-47D8-9B88-D5CD95D195EB}"/>
              </a:ext>
            </a:extLst>
          </p:cNvPr>
          <p:cNvSpPr txBox="1"/>
          <p:nvPr/>
        </p:nvSpPr>
        <p:spPr>
          <a:xfrm>
            <a:off x="-81792" y="48186"/>
            <a:ext cx="325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33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F120182F-4261-456D-BAA1-C63412766C4B}"/>
              </a:ext>
            </a:extLst>
          </p:cNvPr>
          <p:cNvSpPr txBox="1"/>
          <p:nvPr/>
        </p:nvSpPr>
        <p:spPr>
          <a:xfrm>
            <a:off x="-18888" y="2743200"/>
            <a:ext cx="325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33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8392B281-04B1-4CF7-A227-48E5D89D9214}"/>
              </a:ext>
            </a:extLst>
          </p:cNvPr>
          <p:cNvSpPr txBox="1"/>
          <p:nvPr/>
        </p:nvSpPr>
        <p:spPr>
          <a:xfrm>
            <a:off x="797059" y="143259"/>
            <a:ext cx="1017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VCAM1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2DF0ECC3-9F27-4102-AD9A-F4178A44FBDB}"/>
              </a:ext>
            </a:extLst>
          </p:cNvPr>
          <p:cNvSpPr txBox="1"/>
          <p:nvPr/>
        </p:nvSpPr>
        <p:spPr>
          <a:xfrm>
            <a:off x="2377235" y="136582"/>
            <a:ext cx="907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GFBP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1B5D75E-56F2-4A8C-A91A-4D8C9611E685}"/>
              </a:ext>
            </a:extLst>
          </p:cNvPr>
          <p:cNvSpPr txBox="1"/>
          <p:nvPr/>
        </p:nvSpPr>
        <p:spPr>
          <a:xfrm>
            <a:off x="635783" y="2819400"/>
            <a:ext cx="11368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NFRS11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9BE2D88-F2A8-49B8-8CA9-13CAA938DE24}"/>
              </a:ext>
            </a:extLst>
          </p:cNvPr>
          <p:cNvSpPr txBox="1"/>
          <p:nvPr/>
        </p:nvSpPr>
        <p:spPr>
          <a:xfrm>
            <a:off x="2445116" y="2819400"/>
            <a:ext cx="907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MP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10C491F-45C1-4A4F-967D-F8A3BBC4E3E6}"/>
              </a:ext>
            </a:extLst>
          </p:cNvPr>
          <p:cNvSpPr txBox="1"/>
          <p:nvPr/>
        </p:nvSpPr>
        <p:spPr>
          <a:xfrm>
            <a:off x="7772400" y="2864609"/>
            <a:ext cx="11791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iR-140-5p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4644694-F7EA-4E77-B25D-129166C2D8A8}"/>
              </a:ext>
            </a:extLst>
          </p:cNvPr>
          <p:cNvSpPr txBox="1"/>
          <p:nvPr/>
        </p:nvSpPr>
        <p:spPr>
          <a:xfrm>
            <a:off x="5257800" y="2743200"/>
            <a:ext cx="325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33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CBAA28F-5CCD-4340-8FE9-1C9AD1884007}"/>
              </a:ext>
            </a:extLst>
          </p:cNvPr>
          <p:cNvSpPr txBox="1"/>
          <p:nvPr/>
        </p:nvSpPr>
        <p:spPr>
          <a:xfrm>
            <a:off x="4174666" y="144520"/>
            <a:ext cx="113684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TBG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C5681DA-715B-40CE-9983-0EF84C10C5EB}"/>
              </a:ext>
            </a:extLst>
          </p:cNvPr>
          <p:cNvSpPr txBox="1"/>
          <p:nvPr/>
        </p:nvSpPr>
        <p:spPr>
          <a:xfrm>
            <a:off x="5929951" y="138020"/>
            <a:ext cx="10175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HBS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9DDD69EB-55A7-4B5F-A932-444DF35F9F67}"/>
              </a:ext>
            </a:extLst>
          </p:cNvPr>
          <p:cNvSpPr txBox="1"/>
          <p:nvPr/>
        </p:nvSpPr>
        <p:spPr>
          <a:xfrm>
            <a:off x="4013433" y="2819400"/>
            <a:ext cx="907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ENK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AC5219C3-34A7-4168-99CB-33793DA63E9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8543048"/>
              </p:ext>
            </p:extLst>
          </p:nvPr>
        </p:nvGraphicFramePr>
        <p:xfrm>
          <a:off x="5491724" y="508412"/>
          <a:ext cx="1600200" cy="2084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1594681" imgH="2277298" progId="Prism9.Document">
                  <p:embed/>
                </p:oleObj>
              </mc:Choice>
              <mc:Fallback>
                <p:oleObj name="Prism 9" r:id="rId3" imgW="1594681" imgH="2277298" progId="Prism9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AC5219C3-34A7-4168-99CB-33793DA63E96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491724" y="508412"/>
                        <a:ext cx="1600200" cy="2084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5C70E291-0DF6-40DF-94C8-EDBA808BA68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4437682"/>
              </p:ext>
            </p:extLst>
          </p:nvPr>
        </p:nvGraphicFramePr>
        <p:xfrm>
          <a:off x="168275" y="533400"/>
          <a:ext cx="1619250" cy="20748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1712085" imgH="2226892" progId="Prism9.Document">
                  <p:embed/>
                </p:oleObj>
              </mc:Choice>
              <mc:Fallback>
                <p:oleObj name="Prism 9" r:id="rId5" imgW="1712085" imgH="2226892" progId="Prism9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5C70E291-0DF6-40DF-94C8-EDBA808BA68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8275" y="533400"/>
                        <a:ext cx="1619250" cy="20748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9E4B38F3-8177-4593-A83A-89DE4A4A1A6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3385918"/>
              </p:ext>
            </p:extLst>
          </p:nvPr>
        </p:nvGraphicFramePr>
        <p:xfrm>
          <a:off x="1912098" y="498197"/>
          <a:ext cx="1620837" cy="20979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1712085" imgH="2275498" progId="Prism9.Document">
                  <p:embed/>
                </p:oleObj>
              </mc:Choice>
              <mc:Fallback>
                <p:oleObj name="Prism 9" r:id="rId7" imgW="1712085" imgH="2275498" progId="Prism9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9E4B38F3-8177-4593-A83A-89DE4A4A1A6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12098" y="498197"/>
                        <a:ext cx="1620837" cy="20979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2B843716-75F0-406E-B300-EE03B9060E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6230026"/>
              </p:ext>
            </p:extLst>
          </p:nvPr>
        </p:nvGraphicFramePr>
        <p:xfrm>
          <a:off x="3701591" y="514912"/>
          <a:ext cx="1598613" cy="2081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1594681" imgH="2257496" progId="Prism9.Document">
                  <p:embed/>
                </p:oleObj>
              </mc:Choice>
              <mc:Fallback>
                <p:oleObj name="Prism 9" r:id="rId9" imgW="1594681" imgH="2257496" progId="Prism9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2B843716-75F0-406E-B300-EE03B9060E3B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01591" y="514912"/>
                        <a:ext cx="1598613" cy="2081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ct 20">
            <a:extLst>
              <a:ext uri="{FF2B5EF4-FFF2-40B4-BE49-F238E27FC236}">
                <a16:creationId xmlns:a16="http://schemas.microsoft.com/office/drawing/2014/main" id="{99B3AE66-122B-4588-973E-622ABD7674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2518613"/>
              </p:ext>
            </p:extLst>
          </p:nvPr>
        </p:nvGraphicFramePr>
        <p:xfrm>
          <a:off x="7391400" y="3231918"/>
          <a:ext cx="1660510" cy="2149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1712085" imgH="2202408" progId="Prism9.Document">
                  <p:embed/>
                </p:oleObj>
              </mc:Choice>
              <mc:Fallback>
                <p:oleObj name="Prism 9" r:id="rId11" imgW="1712085" imgH="2202408" progId="Prism9.Document">
                  <p:embed/>
                  <p:pic>
                    <p:nvPicPr>
                      <p:cNvPr id="21" name="Object 20">
                        <a:extLst>
                          <a:ext uri="{FF2B5EF4-FFF2-40B4-BE49-F238E27FC236}">
                            <a16:creationId xmlns:a16="http://schemas.microsoft.com/office/drawing/2014/main" id="{99B3AE66-122B-4588-973E-622ABD767484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391400" y="3231918"/>
                        <a:ext cx="1660510" cy="2149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ct 21">
            <a:extLst>
              <a:ext uri="{FF2B5EF4-FFF2-40B4-BE49-F238E27FC236}">
                <a16:creationId xmlns:a16="http://schemas.microsoft.com/office/drawing/2014/main" id="{6F76C0B2-53B1-4E68-AC9A-EB33B09C12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7639097"/>
              </p:ext>
            </p:extLst>
          </p:nvPr>
        </p:nvGraphicFramePr>
        <p:xfrm>
          <a:off x="3505200" y="3127177"/>
          <a:ext cx="1598613" cy="22790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1594681" imgH="2202408" progId="Prism9.Document">
                  <p:embed/>
                </p:oleObj>
              </mc:Choice>
              <mc:Fallback>
                <p:oleObj name="Prism 9" r:id="rId13" imgW="1594681" imgH="2202408" progId="Prism9.Document">
                  <p:embed/>
                  <p:pic>
                    <p:nvPicPr>
                      <p:cNvPr id="22" name="Object 21">
                        <a:extLst>
                          <a:ext uri="{FF2B5EF4-FFF2-40B4-BE49-F238E27FC236}">
                            <a16:creationId xmlns:a16="http://schemas.microsoft.com/office/drawing/2014/main" id="{6F76C0B2-53B1-4E68-AC9A-EB33B09C12EA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05200" y="3127177"/>
                        <a:ext cx="1598613" cy="22790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ct 22">
            <a:extLst>
              <a:ext uri="{FF2B5EF4-FFF2-40B4-BE49-F238E27FC236}">
                <a16:creationId xmlns:a16="http://schemas.microsoft.com/office/drawing/2014/main" id="{02F05029-3734-46DD-A694-132638F3604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1612746"/>
              </p:ext>
            </p:extLst>
          </p:nvPr>
        </p:nvGraphicFramePr>
        <p:xfrm>
          <a:off x="1752600" y="3207115"/>
          <a:ext cx="1659551" cy="21990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1750260" imgH="2260376" progId="Prism9.Document">
                  <p:embed/>
                </p:oleObj>
              </mc:Choice>
              <mc:Fallback>
                <p:oleObj name="Prism 9" r:id="rId15" imgW="1750260" imgH="2260376" progId="Prism9.Document">
                  <p:embed/>
                  <p:pic>
                    <p:nvPicPr>
                      <p:cNvPr id="23" name="Object 22">
                        <a:extLst>
                          <a:ext uri="{FF2B5EF4-FFF2-40B4-BE49-F238E27FC236}">
                            <a16:creationId xmlns:a16="http://schemas.microsoft.com/office/drawing/2014/main" id="{02F05029-3734-46DD-A694-132638F3604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752600" y="3207115"/>
                        <a:ext cx="1659551" cy="21990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ct 23">
            <a:extLst>
              <a:ext uri="{FF2B5EF4-FFF2-40B4-BE49-F238E27FC236}">
                <a16:creationId xmlns:a16="http://schemas.microsoft.com/office/drawing/2014/main" id="{649B2D00-C565-4F43-AD65-F8A5A1C29C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9538619"/>
              </p:ext>
            </p:extLst>
          </p:nvPr>
        </p:nvGraphicFramePr>
        <p:xfrm>
          <a:off x="138113" y="3158297"/>
          <a:ext cx="1614487" cy="2247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7" imgW="1672470" imgH="2261816" progId="Prism9.Document">
                  <p:embed/>
                </p:oleObj>
              </mc:Choice>
              <mc:Fallback>
                <p:oleObj name="Prism 9" r:id="rId17" imgW="1672470" imgH="2261816" progId="Prism9.Document">
                  <p:embed/>
                  <p:pic>
                    <p:nvPicPr>
                      <p:cNvPr id="24" name="Object 23">
                        <a:extLst>
                          <a:ext uri="{FF2B5EF4-FFF2-40B4-BE49-F238E27FC236}">
                            <a16:creationId xmlns:a16="http://schemas.microsoft.com/office/drawing/2014/main" id="{649B2D00-C565-4F43-AD65-F8A5A1C29C0C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38113" y="3158297"/>
                        <a:ext cx="1614487" cy="2247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CCAB647C-9CEC-CDBE-4DCB-EA539E32C5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86809826"/>
              </p:ext>
            </p:extLst>
          </p:nvPr>
        </p:nvGraphicFramePr>
        <p:xfrm>
          <a:off x="7393554" y="494933"/>
          <a:ext cx="1710011" cy="2079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9" imgW="1828049" imgH="2202408" progId="Prism9.Document">
                  <p:embed/>
                </p:oleObj>
              </mc:Choice>
              <mc:Fallback>
                <p:oleObj name="Prism 9" r:id="rId19" imgW="1828049" imgH="2202408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FA7EF3A1-7DBB-4549-B408-10599CECA9A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7393554" y="494933"/>
                        <a:ext cx="1710011" cy="2079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9">
            <a:extLst>
              <a:ext uri="{FF2B5EF4-FFF2-40B4-BE49-F238E27FC236}">
                <a16:creationId xmlns:a16="http://schemas.microsoft.com/office/drawing/2014/main" id="{536A6187-72DE-5C77-AEB0-A12CA01D1143}"/>
              </a:ext>
            </a:extLst>
          </p:cNvPr>
          <p:cNvSpPr txBox="1"/>
          <p:nvPr/>
        </p:nvSpPr>
        <p:spPr>
          <a:xfrm>
            <a:off x="7923947" y="187156"/>
            <a:ext cx="636677" cy="307777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SP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954101E-652D-A987-E0C4-76C038DF425A}"/>
              </a:ext>
            </a:extLst>
          </p:cNvPr>
          <p:cNvSpPr txBox="1"/>
          <p:nvPr/>
        </p:nvSpPr>
        <p:spPr>
          <a:xfrm>
            <a:off x="7212013" y="99179"/>
            <a:ext cx="3254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336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3" name="TextBox 30">
            <a:extLst>
              <a:ext uri="{FF2B5EF4-FFF2-40B4-BE49-F238E27FC236}">
                <a16:creationId xmlns:a16="http://schemas.microsoft.com/office/drawing/2014/main" id="{4F4F8D77-DE05-53B3-751E-24926A6933F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831156" y="1466365"/>
            <a:ext cx="2801559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16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</a:t>
            </a:r>
            <a:r>
              <a:rPr lang="pl-PL" altLang="zh-CN" sz="16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/mL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9D49A49-A013-1318-72C8-9BDAD35069AE}"/>
              </a:ext>
            </a:extLst>
          </p:cNvPr>
          <p:cNvGrpSpPr/>
          <p:nvPr/>
        </p:nvGrpSpPr>
        <p:grpSpPr>
          <a:xfrm>
            <a:off x="3954952" y="5576890"/>
            <a:ext cx="1521128" cy="894730"/>
            <a:chOff x="2354022" y="5582270"/>
            <a:chExt cx="1521128" cy="894730"/>
          </a:xfrm>
        </p:grpSpPr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84C415EE-1FB3-4FFB-9D45-0220121E309D}"/>
                </a:ext>
              </a:extLst>
            </p:cNvPr>
            <p:cNvGrpSpPr/>
            <p:nvPr/>
          </p:nvGrpSpPr>
          <p:grpSpPr>
            <a:xfrm>
              <a:off x="2354022" y="5582270"/>
              <a:ext cx="1521128" cy="894730"/>
              <a:chOff x="5650105" y="3473971"/>
              <a:chExt cx="1167610" cy="894730"/>
            </a:xfrm>
          </p:grpSpPr>
          <p:sp>
            <p:nvSpPr>
              <p:cNvPr id="100" name="Rectangle 99">
                <a:extLst>
                  <a:ext uri="{FF2B5EF4-FFF2-40B4-BE49-F238E27FC236}">
                    <a16:creationId xmlns:a16="http://schemas.microsoft.com/office/drawing/2014/main" id="{F0EB8162-275D-4663-A2C1-6D298C1F9E2C}"/>
                  </a:ext>
                </a:extLst>
              </p:cNvPr>
              <p:cNvSpPr/>
              <p:nvPr/>
            </p:nvSpPr>
            <p:spPr>
              <a:xfrm>
                <a:off x="5710259" y="3604059"/>
                <a:ext cx="154794" cy="75860"/>
              </a:xfrm>
              <a:prstGeom prst="rect">
                <a:avLst/>
              </a:prstGeom>
              <a:solidFill>
                <a:srgbClr val="FF6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 dirty="0"/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F1B8EE9B-B4D5-4EF5-9164-01FEF1B4823C}"/>
                  </a:ext>
                </a:extLst>
              </p:cNvPr>
              <p:cNvSpPr txBox="1"/>
              <p:nvPr/>
            </p:nvSpPr>
            <p:spPr>
              <a:xfrm>
                <a:off x="5814082" y="3514625"/>
                <a:ext cx="100363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-MSC</a:t>
                </a:r>
              </a:p>
            </p:txBody>
          </p:sp>
          <p:sp>
            <p:nvSpPr>
              <p:cNvPr id="102" name="Rectangle 101">
                <a:extLst>
                  <a:ext uri="{FF2B5EF4-FFF2-40B4-BE49-F238E27FC236}">
                    <a16:creationId xmlns:a16="http://schemas.microsoft.com/office/drawing/2014/main" id="{34695B6E-370E-46F4-967E-D4557818D85F}"/>
                  </a:ext>
                </a:extLst>
              </p:cNvPr>
              <p:cNvSpPr/>
              <p:nvPr/>
            </p:nvSpPr>
            <p:spPr>
              <a:xfrm>
                <a:off x="5710260" y="3796116"/>
                <a:ext cx="154793" cy="77248"/>
              </a:xfrm>
              <a:prstGeom prst="rect">
                <a:avLst/>
              </a:prstGeom>
              <a:solidFill>
                <a:srgbClr val="0000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00" dirty="0"/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71D8C642-617B-46B8-933A-33D4F896A78D}"/>
                  </a:ext>
                </a:extLst>
              </p:cNvPr>
              <p:cNvSpPr txBox="1"/>
              <p:nvPr/>
            </p:nvSpPr>
            <p:spPr>
              <a:xfrm>
                <a:off x="5814082" y="3716179"/>
                <a:ext cx="92743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KD-MSC</a:t>
                </a:r>
              </a:p>
            </p:txBody>
          </p:sp>
          <p:sp>
            <p:nvSpPr>
              <p:cNvPr id="104" name="Rectangle 103">
                <a:extLst>
                  <a:ext uri="{FF2B5EF4-FFF2-40B4-BE49-F238E27FC236}">
                    <a16:creationId xmlns:a16="http://schemas.microsoft.com/office/drawing/2014/main" id="{0FA770F7-9302-4F2C-995F-73E8F61454A3}"/>
                  </a:ext>
                </a:extLst>
              </p:cNvPr>
              <p:cNvSpPr/>
              <p:nvPr/>
            </p:nvSpPr>
            <p:spPr>
              <a:xfrm>
                <a:off x="5650105" y="3473971"/>
                <a:ext cx="1099891" cy="89473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888CE209-237E-1733-9248-74D1A261DEB8}"/>
                </a:ext>
              </a:extLst>
            </p:cNvPr>
            <p:cNvSpPr/>
            <p:nvPr/>
          </p:nvSpPr>
          <p:spPr>
            <a:xfrm>
              <a:off x="2433515" y="6107581"/>
              <a:ext cx="201660" cy="8274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ACAD0E0-DAA4-6710-1192-BE7D059651A8}"/>
                </a:ext>
              </a:extLst>
            </p:cNvPr>
            <p:cNvSpPr txBox="1"/>
            <p:nvPr/>
          </p:nvSpPr>
          <p:spPr>
            <a:xfrm>
              <a:off x="2567648" y="6018147"/>
              <a:ext cx="1198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ontrol-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SCc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81E2ADF2-F486-ACDF-0EB0-5CF0F8D8120C}"/>
                </a:ext>
              </a:extLst>
            </p:cNvPr>
            <p:cNvSpPr/>
            <p:nvPr/>
          </p:nvSpPr>
          <p:spPr>
            <a:xfrm>
              <a:off x="2433515" y="6299638"/>
              <a:ext cx="201659" cy="84258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63A52865-EFEC-0410-9E3F-416F7A225FDD}"/>
                </a:ext>
              </a:extLst>
            </p:cNvPr>
            <p:cNvSpPr txBox="1"/>
            <p:nvPr/>
          </p:nvSpPr>
          <p:spPr>
            <a:xfrm>
              <a:off x="2567648" y="6219701"/>
              <a:ext cx="11077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KD-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SCcm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9" name="TextBox 30">
            <a:extLst>
              <a:ext uri="{FF2B5EF4-FFF2-40B4-BE49-F238E27FC236}">
                <a16:creationId xmlns:a16="http://schemas.microsoft.com/office/drawing/2014/main" id="{FB2E6A6D-5394-7AED-C7ED-07714E82826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929453" y="3690073"/>
            <a:ext cx="29469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old change (vs. GAPDH)</a:t>
            </a:r>
            <a:endParaRPr lang="zh-CN" altLang="en-US" sz="1200" b="1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0" name="TextBox 30">
            <a:extLst>
              <a:ext uri="{FF2B5EF4-FFF2-40B4-BE49-F238E27FC236}">
                <a16:creationId xmlns:a16="http://schemas.microsoft.com/office/drawing/2014/main" id="{83CC0EDF-A098-1D6B-7D78-39F6E288B4F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362198" y="996276"/>
            <a:ext cx="29469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old change (vs. GAPDH)</a:t>
            </a:r>
            <a:endParaRPr lang="zh-CN" altLang="en-US" sz="1200" b="1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1" name="TextBox 30">
            <a:extLst>
              <a:ext uri="{FF2B5EF4-FFF2-40B4-BE49-F238E27FC236}">
                <a16:creationId xmlns:a16="http://schemas.microsoft.com/office/drawing/2014/main" id="{88F3D637-9E7A-8469-9E36-F98EE14592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371837" y="3794210"/>
            <a:ext cx="29469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12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old change (vs. GAPDH)</a:t>
            </a:r>
            <a:endParaRPr lang="zh-CN" altLang="en-US" sz="1200" b="1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aphicFrame>
        <p:nvGraphicFramePr>
          <p:cNvPr id="43" name="Object 42">
            <a:extLst>
              <a:ext uri="{FF2B5EF4-FFF2-40B4-BE49-F238E27FC236}">
                <a16:creationId xmlns:a16="http://schemas.microsoft.com/office/drawing/2014/main" id="{9DF25115-1272-EB22-1009-6370D14B4D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4670170"/>
              </p:ext>
            </p:extLst>
          </p:nvPr>
        </p:nvGraphicFramePr>
        <p:xfrm>
          <a:off x="5562600" y="3160713"/>
          <a:ext cx="1595438" cy="2212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1" imgW="1594681" imgH="2213210" progId="Prism9.Document">
                  <p:embed/>
                </p:oleObj>
              </mc:Choice>
              <mc:Fallback>
                <p:oleObj name="Prism 9" r:id="rId21" imgW="1594681" imgH="2213210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DA51D3DA-F479-05DF-BEFE-8297F07D59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562600" y="3160713"/>
                        <a:ext cx="1595438" cy="2212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TextBox 43">
            <a:extLst>
              <a:ext uri="{FF2B5EF4-FFF2-40B4-BE49-F238E27FC236}">
                <a16:creationId xmlns:a16="http://schemas.microsoft.com/office/drawing/2014/main" id="{A53BF0FE-DF18-FA5A-70F2-953F10427E3C}"/>
              </a:ext>
            </a:extLst>
          </p:cNvPr>
          <p:cNvSpPr txBox="1"/>
          <p:nvPr/>
        </p:nvSpPr>
        <p:spPr>
          <a:xfrm>
            <a:off x="5774443" y="2864608"/>
            <a:ext cx="131215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let-7a-5p</a:t>
            </a:r>
          </a:p>
        </p:txBody>
      </p:sp>
    </p:spTree>
    <p:extLst>
      <p:ext uri="{BB962C8B-B14F-4D97-AF65-F5344CB8AC3E}">
        <p14:creationId xmlns:p14="http://schemas.microsoft.com/office/powerpoint/2010/main" val="2849229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72</TotalTime>
  <Words>47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9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SC Biopsy Paracrine Manuscript 4-29-2019</dc:title>
  <dc:creator>LaTonya J Hickson</dc:creator>
  <cp:lastModifiedBy>LaTonya Hickson</cp:lastModifiedBy>
  <cp:revision>444</cp:revision>
  <cp:lastPrinted>2021-05-04T16:39:54Z</cp:lastPrinted>
  <dcterms:created xsi:type="dcterms:W3CDTF">2019-04-29T22:14:18Z</dcterms:created>
  <dcterms:modified xsi:type="dcterms:W3CDTF">2022-08-16T18:03:04Z</dcterms:modified>
</cp:coreProperties>
</file>